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16" y="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65D45-7757-4772-BF8E-32C9FF010D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7FD0E5-DA40-493A-B5C9-AAB8EED3E3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CDA4F4-1F73-44CB-BCDF-2CBD90A64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9D33CA-B731-4335-BFC3-D5BD3EA67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7BCBBA-8D91-4106-994E-B69D2EA20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73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E396D-96C5-4A76-9245-EE43FF72E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C186A4-2658-4552-899D-26FF9957CE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FCCAAC-B298-4A3C-B9AB-67911174C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7B6295-553B-4A65-9E6E-BD52EE34B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4D71B0-97A0-4FE5-893A-8964A4689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007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91B595-AE7D-4D18-A084-A7624A3C0C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18D087-41BD-497F-AFFC-FC8C1B3C34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0D5325-8D35-4D97-8654-EF38234D9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4309F4-E66A-4D63-843F-A913E9663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4DFAC7-011E-4CCE-876B-1B5F35769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752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5AD787-F16D-43FB-AF0B-1879FF914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7264E3-8870-4147-BDAF-83256A4ACB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6FA34B-A104-4C99-A729-B0E61CE98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B8E0F9-7829-45C3-BA39-D8C3CE66F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1E58BE-B286-43DA-9ACC-E05B8A629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54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8E959-405F-49FB-AEFD-5BEC39476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49E98C-04D8-4F05-B2C7-1427B46235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445E04-F6F6-483C-B353-402C89AC8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214935-4F8C-439B-A374-6CA16FFD4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F88493-7752-4706-A173-9AC3C2A8D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46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1CD255-F73F-4A70-B47D-0056886D8A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88AFCB-FF84-406D-98DE-81DCB925F0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DB4B08-DFE7-472C-86EA-0DC9CA2198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25BF22-DE3B-43D0-969D-012BF9E9A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C1F42A-FEE5-45F9-8E01-0EF6045C3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DE266E-5706-45B6-8A85-D033E8978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377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EDB4E-4E70-4428-8E93-F4AED99BD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E36032-444B-47F3-B7A6-9BE5F890C9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56FE75-112F-4695-97FA-28F03C846E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8C98BA-1027-48C1-B342-6588756761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DB6D087-8102-4342-A6C7-178F91A23C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AF861D-A8AB-4257-9F3D-632133A94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41D63-5A5E-4D35-BECE-4948775E9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E6D309-ADAF-45FE-BF63-1E5C28DFE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415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608CF-B0CA-4FA9-8F70-4C38576485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AECDA8-6A13-452A-AB3F-6DE2C373E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E52755-26BA-4DDF-918C-EEFDD9C90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68DFDA-F488-4962-AECD-DD3795F66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82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C8F135-CB21-4C5F-AEC4-9FD5A8CF6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9076CF-C67F-4EF2-AFF5-E6A5FB3D3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E129D2-243A-4B6D-A4F2-F965AC6A4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79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908AB-C88C-4D00-B795-52C96BC62B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7A311E-E7AA-4913-BBBA-0005C26D25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3400DC-6532-4BC7-9DE3-9CE28BE9E0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CCDD55-22AD-431E-9899-6C4CAC467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C91945-A192-41FE-8A86-897514437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976BB3-AC1B-408C-BB1F-E42135065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986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A0079-87F5-4910-A64A-02CCFDB54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91D9F3-7B03-428D-A203-B7ED9DBD96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F82E83-EE5A-43B4-8710-6DA32647A1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5153A7-C2B2-42DF-BA78-270D3A778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84C7D5-8A2E-40C7-B0EE-EACF18E252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406963-5B96-4F75-B324-B24FF80C1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870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14DD55-A15F-4731-9F5F-B14C61BED6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90F15D-B891-45A2-8B5C-7B1CF3CB63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4B2D81-3DE2-431F-A361-29782C6AD3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0FE27-D705-41D2-9BCE-2F559550B309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9CBB-45C0-4509-A678-269483AC7C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48A4A-B07B-416C-978B-6A46F4F9E1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9BA3EE-E795-446E-A4C8-11EE7615C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414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1777D52F-711A-4656-AF20-D94D545571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817822" y="1007707"/>
            <a:ext cx="5694784" cy="4758611"/>
          </a:xfrm>
        </p:spPr>
        <p:txBody>
          <a:bodyPr>
            <a:normAutofit/>
          </a:bodyPr>
          <a:lstStyle/>
          <a:p>
            <a:pPr algn="l"/>
            <a:r>
              <a:rPr lang="en-US" sz="16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2. Mycorrhization assay of </a:t>
            </a:r>
            <a:r>
              <a:rPr lang="en-US" sz="16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actarius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</a:p>
          <a:p>
            <a:pPr algn="l"/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Each of the four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actarius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pecies was paired with five differen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inus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pecies to assay their ectomycorrhizal compatibility </a:t>
            </a:r>
            <a:r>
              <a:rPr lang="en-US" sz="1600" b="1" dirty="0">
                <a:latin typeface="Times New Roman" panose="02020603050405020304" pitchFamily="18" charset="0"/>
                <a:ea typeface="宋体" panose="02010600030101010101" pitchFamily="2" charset="-122"/>
              </a:rPr>
              <a:t>(A)</a:t>
            </a:r>
            <a:r>
              <a:rPr lang="en-US" sz="1600" dirty="0">
                <a:latin typeface="Times New Roman" panose="02020603050405020304" pitchFamily="18" charset="0"/>
                <a:ea typeface="宋体" panose="02010600030101010101" pitchFamily="2" charset="-122"/>
              </a:rPr>
              <a:t>;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Compatible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actarius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-Pinus 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ombinations leading to symbiosis development are indicated as “+” while incompatible combinations as “–”. The four interactions highlighted in orange were used </a:t>
            </a:r>
            <a:r>
              <a:rPr lang="en-US" sz="16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or RNA 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equencing. In addition to the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eliciosus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-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eda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ectomycorrhizal roots shown in Fig.1, ectomycorrhizal roots of three other compatible combinations were checked by stereomicroscopy, including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kahatsu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buliformis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B)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anguifluus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ylvestris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C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), and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ividus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eda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D)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Agarose-embedded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ividus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-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eda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ections (50 µm), stained with WGA-FITC were further checked for the presence of mantle and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artig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net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E)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Abbreviations: M, Mantle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n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artig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net; Pm,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inus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assoniana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Ps,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ylvestris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tab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buliformis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tae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eda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y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.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yunnanensis</a:t>
            </a:r>
            <a:r>
              <a:rPr lang="en-US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Scale bar in b-d: 1 mm and in e: 100 µm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1D6D260-009F-46EB-BDA9-1B32517BCE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521" y="664912"/>
            <a:ext cx="4487045" cy="544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3669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00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唐TANG 年武Nianwu</dc:creator>
  <cp:lastModifiedBy>Nianwu</cp:lastModifiedBy>
  <cp:revision>7</cp:revision>
  <dcterms:created xsi:type="dcterms:W3CDTF">2021-05-13T10:06:56Z</dcterms:created>
  <dcterms:modified xsi:type="dcterms:W3CDTF">2021-07-12T11:39:15Z</dcterms:modified>
</cp:coreProperties>
</file>